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770" r:id="rId1"/>
    <p:sldMasterId id="2147483917" r:id="rId2"/>
  </p:sldMasterIdLst>
  <p:sldIdLst>
    <p:sldId id="256" r:id="rId3"/>
    <p:sldId id="258" r:id="rId4"/>
    <p:sldId id="257" r:id="rId5"/>
    <p:sldId id="260" r:id="rId6"/>
    <p:sldId id="261" r:id="rId7"/>
    <p:sldId id="267" r:id="rId8"/>
    <p:sldId id="265" r:id="rId9"/>
    <p:sldId id="264" r:id="rId10"/>
    <p:sldId id="259" r:id="rId11"/>
    <p:sldId id="266" r:id="rId12"/>
    <p:sldId id="269" r:id="rId13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34587" autoAdjust="0"/>
    <p:restoredTop sz="94673" autoAdjust="0"/>
  </p:normalViewPr>
  <p:slideViewPr>
    <p:cSldViewPr>
      <p:cViewPr varScale="1">
        <p:scale>
          <a:sx n="77" d="100"/>
          <a:sy n="77" d="100"/>
        </p:scale>
        <p:origin x="-1422" y="-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viewProps" Target="viewProps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 anchor="ctr">
            <a:noAutofit/>
          </a:bodyPr>
          <a:lstStyle>
            <a:lvl1pPr algn="ctr">
              <a:defRPr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accent4">
                    <a:lumMod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75281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C16CF0D-7B0C-5C4D-9CCD-D300DE320234}" type="datetime1">
              <a:rPr lang="en-US" smtClean="0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A78F22A-28D6-A149-935A-0331A5F12D7C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664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497CF255-F9C0-3E4E-A3B0-91189C832E6B}" type="datetime1">
              <a:rPr lang="en-US" smtClean="0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771BE5A-A983-314C-8ED4-9AE417782947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10950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CECAE7E-8EFB-1245-BE22-25B645EB9D72}" type="datetime1">
              <a:rPr lang="en-US" smtClean="0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EDA595A-9216-E343-AEDF-21F5495D155D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9811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8E852E4-D416-4A4D-AAB6-D91271A032FC}" type="datetime1">
              <a:rPr lang="en-US" smtClean="0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D25B1BF-4126-464B-BDA0-56194785627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41496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593A5E9-3E5C-904E-B9F4-15870439CD17}" type="datetime1">
              <a:rPr lang="en-US" smtClean="0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93987B2-AE62-F44C-BE01-1608B032CE12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32585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C16CF0D-7B0C-5C4D-9CCD-D300DE320234}" type="datetime1">
              <a:rPr lang="en-US" smtClean="0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A78F22A-28D6-A149-935A-0331A5F12D7C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32326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C16CF0D-7B0C-5C4D-9CCD-D300DE320234}" type="datetime1">
              <a:rPr lang="en-US" smtClean="0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A78F22A-28D6-A149-935A-0331A5F12D7C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20233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B971924-B330-C648-9B8B-43862660211D}" type="datetime1">
              <a:rPr lang="en-US" smtClean="0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FE96353-74CF-B74B-B18B-23E1CF9EA9DB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85387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C16CF0D-7B0C-5C4D-9CCD-D300DE320234}" type="datetime1">
              <a:rPr lang="en-US" smtClean="0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A78F22A-28D6-A149-935A-0331A5F12D7C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000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accent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0038F6-5ABA-E34B-ACD9-3A56EC1E1DC3}" type="datetime1">
              <a:rPr lang="en-US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EF4314-E115-4541-9702-0FD496A07D4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34895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1524001"/>
            <a:ext cx="3028950" cy="6644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524001"/>
            <a:ext cx="3028950" cy="66442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7CF255-F9C0-3E4E-A3B0-91189C832E6B}" type="datetime1">
              <a:rPr lang="en-US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71BE5A-A983-314C-8ED4-9AE41778294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9462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1524000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438401"/>
            <a:ext cx="3030141" cy="572981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1524000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438401"/>
            <a:ext cx="3031331" cy="572981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ECAE7E-8EFB-1245-BE22-25B645EB9D72}" type="datetime1">
              <a:rPr lang="en-US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DA595A-9216-E343-AEDF-21F5495D155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85319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E852E4-D416-4A4D-AAB6-D91271A032FC}" type="datetime1">
              <a:rPr lang="en-US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25B1BF-4126-464B-BDA0-56194785627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71503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93A5E9-3E5C-904E-B9F4-15870439CD17}" type="datetime1">
              <a:rPr lang="en-US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3987B2-AE62-F44C-BE01-1608B032CE1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97362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1625601"/>
            <a:ext cx="6172200" cy="65426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971924-B330-C648-9B8B-43862660211D}" type="datetime1">
              <a:rPr lang="en-US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E96353-74CF-B74B-B18B-23E1CF9EA9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20056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F3408-907F-465E-96E7-2A7837CC532A}" type="datetimeFigureOut">
              <a:rPr lang="en-GB" smtClean="0"/>
              <a:t>23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B32CF-422D-4683-B809-5E59406EC5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170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80038F6-5ABA-E34B-ACD9-3A56EC1E1DC3}" type="datetime1">
              <a:rPr lang="en-US" smtClean="0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8EF4314-E115-4541-9702-0FD496A07D43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727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1.jp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5.xml"/><Relationship Id="rId3" Type="http://schemas.openxmlformats.org/officeDocument/2006/relationships/slideLayout" Target="../slideLayouts/slideLayout10.xml"/><Relationship Id="rId7" Type="http://schemas.openxmlformats.org/officeDocument/2006/relationships/slideLayout" Target="../slideLayouts/slideLayout14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6" Type="http://schemas.openxmlformats.org/officeDocument/2006/relationships/slideLayout" Target="../slideLayouts/slideLayout13.xml"/><Relationship Id="rId11" Type="http://schemas.openxmlformats.org/officeDocument/2006/relationships/slideLayout" Target="../slideLayouts/slideLayout18.xml"/><Relationship Id="rId5" Type="http://schemas.openxmlformats.org/officeDocument/2006/relationships/slideLayout" Target="../slideLayouts/slideLayout12.xml"/><Relationship Id="rId10" Type="http://schemas.openxmlformats.org/officeDocument/2006/relationships/slideLayout" Target="../slideLayouts/slideLayout17.xml"/><Relationship Id="rId4" Type="http://schemas.openxmlformats.org/officeDocument/2006/relationships/slideLayout" Target="../slideLayouts/slideLayout11.xml"/><Relationship Id="rId9" Type="http://schemas.openxmlformats.org/officeDocument/2006/relationships/slideLayout" Target="../slideLayouts/slideLayout1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9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57150" y="-135644"/>
            <a:ext cx="4286250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/>
              <a:t>Click to edit Master tit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1524001"/>
            <a:ext cx="6172200" cy="6644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0" hangingPunct="0">
              <a:defRPr sz="1200" smtClean="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FC16CF0D-7B0C-5C4D-9CCD-D300DE320234}" type="datetime1">
              <a:rPr lang="en-US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0" hangingPunct="0">
              <a:defRPr sz="1200">
                <a:solidFill>
                  <a:schemeClr val="tx1">
                    <a:tint val="75000"/>
                  </a:schemeClr>
                </a:solidFill>
                <a:ea typeface="ＭＳ Ｐゴシック" charset="-128"/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0" hangingPunct="0">
              <a:defRPr sz="1200" smtClean="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A78F22A-28D6-A149-935A-0331A5F12D7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16" r:id="rId1"/>
    <p:sldLayoutId id="2147483900" r:id="rId2"/>
    <p:sldLayoutId id="2147483901" r:id="rId3"/>
    <p:sldLayoutId id="2147483902" r:id="rId4"/>
    <p:sldLayoutId id="2147483903" r:id="rId5"/>
    <p:sldLayoutId id="2147483904" r:id="rId6"/>
    <p:sldLayoutId id="2147483905" r:id="rId7"/>
  </p:sldLayoutIdLst>
  <p:timing>
    <p:tnLst>
      <p:par>
        <p:cTn id="1" dur="indefinite" restart="never" nodeType="tmRoot"/>
      </p:par>
    </p:tnLst>
  </p:timing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3600" kern="1200">
          <a:solidFill>
            <a:schemeClr val="accent1"/>
          </a:solidFill>
          <a:latin typeface="+mj-lt"/>
          <a:ea typeface="ＭＳ Ｐゴシック" charset="-128"/>
          <a:cs typeface="ＭＳ Ｐゴシック" charset="-128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ＭＳ Ｐゴシック" charset="-128"/>
          <a:cs typeface="ＭＳ Ｐゴシック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ＭＳ Ｐゴシック" charset="-128"/>
          <a:cs typeface="ＭＳ Ｐゴシック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ＭＳ Ｐゴシック" charset="-128"/>
          <a:cs typeface="ＭＳ Ｐゴシック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rgbClr val="E8DF36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rgbClr val="E8DF36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rgbClr val="E8DF36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457200" rtl="0" eaLnBrk="1" fontAlgn="base" hangingPunct="1">
        <a:spcBef>
          <a:spcPct val="0"/>
        </a:spcBef>
        <a:spcAft>
          <a:spcPct val="0"/>
        </a:spcAft>
        <a:defRPr sz="3600">
          <a:solidFill>
            <a:srgbClr val="E8DF36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342900" indent="-342900" algn="l" defTabSz="457200" rtl="0" eaLnBrk="1" fontAlgn="base" hangingPunct="1">
        <a:spcBef>
          <a:spcPts val="15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-128"/>
          <a:cs typeface="+mn-cs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C16CF0D-7B0C-5C4D-9CCD-D300DE320234}" type="datetime1">
              <a:rPr lang="en-US" smtClean="0"/>
              <a:pPr>
                <a:defRPr/>
              </a:pPr>
              <a:t>1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7A78F22A-28D6-A149-935A-0331A5F12D7C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881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18" r:id="rId1"/>
    <p:sldLayoutId id="2147483919" r:id="rId2"/>
    <p:sldLayoutId id="2147483920" r:id="rId3"/>
    <p:sldLayoutId id="2147483921" r:id="rId4"/>
    <p:sldLayoutId id="2147483922" r:id="rId5"/>
    <p:sldLayoutId id="2147483923" r:id="rId6"/>
    <p:sldLayoutId id="2147483924" r:id="rId7"/>
    <p:sldLayoutId id="2147483925" r:id="rId8"/>
    <p:sldLayoutId id="2147483926" r:id="rId9"/>
    <p:sldLayoutId id="2147483927" r:id="rId10"/>
    <p:sldLayoutId id="2147483928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8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4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4.xml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4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4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4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72" y="1859800"/>
            <a:ext cx="5832648" cy="688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047" y="453084"/>
            <a:ext cx="5842273" cy="13826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005064" y="874846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Supplementary Figure 1</a:t>
            </a:r>
            <a:endParaRPr lang="en-GB" sz="2000" dirty="0"/>
          </a:p>
        </p:txBody>
      </p:sp>
      <p:sp>
        <p:nvSpPr>
          <p:cNvPr id="5" name="TextBox 4"/>
          <p:cNvSpPr txBox="1"/>
          <p:nvPr/>
        </p:nvSpPr>
        <p:spPr>
          <a:xfrm>
            <a:off x="2852936" y="200998"/>
            <a:ext cx="9738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FLT3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65729336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861048" y="8748464"/>
            <a:ext cx="30636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Supplementary Figure 10</a:t>
            </a:r>
            <a:endParaRPr lang="en-GB" sz="2000" dirty="0"/>
          </a:p>
        </p:txBody>
      </p:sp>
      <p:sp>
        <p:nvSpPr>
          <p:cNvPr id="3" name="TextBox 2"/>
          <p:cNvSpPr txBox="1"/>
          <p:nvPr/>
        </p:nvSpPr>
        <p:spPr>
          <a:xfrm>
            <a:off x="2852936" y="200998"/>
            <a:ext cx="9738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HOTTIP</a:t>
            </a:r>
            <a:endParaRPr lang="en-GB" sz="1600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997" y="539552"/>
            <a:ext cx="5959930" cy="14615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998" y="2013894"/>
            <a:ext cx="5959930" cy="19451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27734553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2" y="35496"/>
            <a:ext cx="2085975" cy="466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861048" y="8748464"/>
            <a:ext cx="30446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Supplementary Figure 11</a:t>
            </a:r>
            <a:endParaRPr lang="en-GB" sz="2000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56" y="396180"/>
            <a:ext cx="6540371" cy="83522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9107813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914" y="107504"/>
            <a:ext cx="6192688" cy="16565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032" y="1764065"/>
            <a:ext cx="6203570" cy="70587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005064" y="874846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Supplementary Figure 2</a:t>
            </a:r>
            <a:endParaRPr lang="en-GB" sz="2000" dirty="0"/>
          </a:p>
        </p:txBody>
      </p:sp>
      <p:sp>
        <p:nvSpPr>
          <p:cNvPr id="5" name="TextBox 4"/>
          <p:cNvSpPr txBox="1"/>
          <p:nvPr/>
        </p:nvSpPr>
        <p:spPr>
          <a:xfrm>
            <a:off x="2852936" y="345014"/>
            <a:ext cx="9738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CSF3R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2604650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170" y="107504"/>
            <a:ext cx="6093296" cy="13694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437" y="1476925"/>
            <a:ext cx="6034891" cy="71275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4005064" y="874846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Supplementary Figure 3</a:t>
            </a:r>
            <a:endParaRPr lang="en-GB" sz="2000" dirty="0"/>
          </a:p>
        </p:txBody>
      </p:sp>
      <p:sp>
        <p:nvSpPr>
          <p:cNvPr id="5" name="TextBox 4"/>
          <p:cNvSpPr txBox="1"/>
          <p:nvPr/>
        </p:nvSpPr>
        <p:spPr>
          <a:xfrm>
            <a:off x="3031213" y="273006"/>
            <a:ext cx="9738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KIT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11499742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40" y="5292080"/>
            <a:ext cx="6309146" cy="22343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009" y="7524328"/>
            <a:ext cx="6334978" cy="7426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40" y="251520"/>
            <a:ext cx="6309147" cy="5030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005064" y="874846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Supplementary Figure 4</a:t>
            </a:r>
            <a:endParaRPr lang="en-GB" sz="2000" dirty="0"/>
          </a:p>
        </p:txBody>
      </p:sp>
      <p:sp>
        <p:nvSpPr>
          <p:cNvPr id="6" name="TextBox 5"/>
          <p:cNvSpPr txBox="1"/>
          <p:nvPr/>
        </p:nvSpPr>
        <p:spPr>
          <a:xfrm>
            <a:off x="2852936" y="35496"/>
            <a:ext cx="9738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LMO2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13705887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904" y="1979712"/>
            <a:ext cx="5999803" cy="67687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56" y="173038"/>
            <a:ext cx="6026051" cy="1813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005064" y="874846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Supplementary Figure 5</a:t>
            </a:r>
            <a:endParaRPr lang="en-GB" sz="2000" dirty="0"/>
          </a:p>
        </p:txBody>
      </p:sp>
      <p:sp>
        <p:nvSpPr>
          <p:cNvPr id="5" name="TextBox 4"/>
          <p:cNvSpPr txBox="1"/>
          <p:nvPr/>
        </p:nvSpPr>
        <p:spPr>
          <a:xfrm>
            <a:off x="2636912" y="395536"/>
            <a:ext cx="9738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IRF8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10743492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632" y="2429847"/>
            <a:ext cx="6408728" cy="2990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863" y="203835"/>
            <a:ext cx="6210878" cy="2152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4399506" y="216898"/>
            <a:ext cx="209006" cy="2152650"/>
          </a:xfrm>
          <a:prstGeom prst="rect">
            <a:avLst/>
          </a:prstGeom>
          <a:solidFill>
            <a:schemeClr val="accent3">
              <a:alpha val="26000"/>
            </a:schemeClr>
          </a:solidFill>
          <a:ln w="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861" y="2880971"/>
            <a:ext cx="6271635" cy="24624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862" y="5511686"/>
            <a:ext cx="6271633" cy="27962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6"/>
          <p:cNvSpPr/>
          <p:nvPr/>
        </p:nvSpPr>
        <p:spPr>
          <a:xfrm>
            <a:off x="6120680" y="2890456"/>
            <a:ext cx="209006" cy="2452933"/>
          </a:xfrm>
          <a:prstGeom prst="rect">
            <a:avLst/>
          </a:prstGeom>
          <a:solidFill>
            <a:schemeClr val="accent3">
              <a:alpha val="26000"/>
            </a:schemeClr>
          </a:solidFill>
          <a:ln w="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/>
          <p:cNvSpPr/>
          <p:nvPr/>
        </p:nvSpPr>
        <p:spPr>
          <a:xfrm>
            <a:off x="4531407" y="5537889"/>
            <a:ext cx="209006" cy="2770089"/>
          </a:xfrm>
          <a:prstGeom prst="rect">
            <a:avLst/>
          </a:prstGeom>
          <a:solidFill>
            <a:schemeClr val="accent3">
              <a:alpha val="26000"/>
            </a:schemeClr>
          </a:solidFill>
          <a:ln w="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/>
          <p:cNvSpPr txBox="1"/>
          <p:nvPr/>
        </p:nvSpPr>
        <p:spPr>
          <a:xfrm>
            <a:off x="4005064" y="874846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Supplementary Figure 6</a:t>
            </a:r>
            <a:endParaRPr lang="en-GB" sz="2000" dirty="0"/>
          </a:p>
        </p:txBody>
      </p:sp>
      <p:sp>
        <p:nvSpPr>
          <p:cNvPr id="10" name="TextBox 9"/>
          <p:cNvSpPr txBox="1"/>
          <p:nvPr/>
        </p:nvSpPr>
        <p:spPr>
          <a:xfrm>
            <a:off x="3895309" y="705054"/>
            <a:ext cx="20539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+35kb enhancer</a:t>
            </a:r>
            <a:endParaRPr lang="en-GB" sz="1600" dirty="0"/>
          </a:p>
        </p:txBody>
      </p:sp>
      <p:sp>
        <p:nvSpPr>
          <p:cNvPr id="3" name="TextBox 2"/>
          <p:cNvSpPr txBox="1"/>
          <p:nvPr/>
        </p:nvSpPr>
        <p:spPr>
          <a:xfrm>
            <a:off x="0" y="-108520"/>
            <a:ext cx="432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-27384" y="2555776"/>
            <a:ext cx="432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-27384" y="5220072"/>
            <a:ext cx="432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473585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8507" y="5940152"/>
            <a:ext cx="6004829" cy="24009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417" y="535577"/>
            <a:ext cx="5922076" cy="52084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3213463" y="530410"/>
            <a:ext cx="261245" cy="5213574"/>
          </a:xfrm>
          <a:prstGeom prst="rect">
            <a:avLst/>
          </a:prstGeom>
          <a:solidFill>
            <a:schemeClr val="accent3">
              <a:alpha val="26000"/>
            </a:schemeClr>
          </a:solidFill>
          <a:ln w="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/>
          <p:cNvSpPr/>
          <p:nvPr/>
        </p:nvSpPr>
        <p:spPr>
          <a:xfrm>
            <a:off x="4607915" y="5940152"/>
            <a:ext cx="261245" cy="2411752"/>
          </a:xfrm>
          <a:prstGeom prst="rect">
            <a:avLst/>
          </a:prstGeom>
          <a:solidFill>
            <a:schemeClr val="accent3">
              <a:alpha val="26000"/>
            </a:schemeClr>
          </a:solidFill>
          <a:ln w="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TextBox 5"/>
          <p:cNvSpPr txBox="1"/>
          <p:nvPr/>
        </p:nvSpPr>
        <p:spPr>
          <a:xfrm>
            <a:off x="4005064" y="874846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Supplementary Figure 7</a:t>
            </a:r>
            <a:endParaRPr lang="en-GB" sz="2000" dirty="0"/>
          </a:p>
        </p:txBody>
      </p:sp>
      <p:sp>
        <p:nvSpPr>
          <p:cNvPr id="2" name="TextBox 1"/>
          <p:cNvSpPr txBox="1"/>
          <p:nvPr/>
        </p:nvSpPr>
        <p:spPr>
          <a:xfrm>
            <a:off x="2317940" y="65940"/>
            <a:ext cx="24072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KIT enhancer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742312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952206" y="242228"/>
            <a:ext cx="13062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Mir 196</a:t>
            </a:r>
            <a:endParaRPr lang="en-GB" dirty="0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80" y="611560"/>
            <a:ext cx="5799908" cy="21354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80" y="2746981"/>
            <a:ext cx="5799908" cy="5878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005064" y="874846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Supplementary Figure 8</a:t>
            </a: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16143074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023" y="1907705"/>
            <a:ext cx="5852306" cy="69118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834" y="298117"/>
            <a:ext cx="5878494" cy="1609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921458" y="-15026"/>
            <a:ext cx="19477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HOTAIRM1</a:t>
            </a:r>
            <a:endParaRPr lang="en-GB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4005064" y="874846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/>
              <a:t>Supplementary Figure 9</a:t>
            </a: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710573372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Roslin Colours 1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6FB34B"/>
      </a:accent1>
      <a:accent2>
        <a:srgbClr val="E4650F"/>
      </a:accent2>
      <a:accent3>
        <a:srgbClr val="67BDE6"/>
      </a:accent3>
      <a:accent4>
        <a:srgbClr val="CE3286"/>
      </a:accent4>
      <a:accent5>
        <a:srgbClr val="FFFF00"/>
      </a:accent5>
      <a:accent6>
        <a:srgbClr val="FF0000"/>
      </a:accent6>
      <a:hlink>
        <a:srgbClr val="E4650F"/>
      </a:hlink>
      <a:folHlink>
        <a:srgbClr val="E4650F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873</TotalTime>
  <Words>50</Words>
  <Application>Microsoft Office PowerPoint</Application>
  <PresentationFormat>On-screen Show (4:3)</PresentationFormat>
  <Paragraphs>24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11</vt:i4>
      </vt:variant>
    </vt:vector>
  </HeadingPairs>
  <TitlesOfParts>
    <vt:vector size="13" baseType="lpstr">
      <vt:lpstr>blank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HI Anagha</dc:creator>
  <cp:lastModifiedBy>JOSHI Anagha</cp:lastModifiedBy>
  <cp:revision>28</cp:revision>
  <dcterms:created xsi:type="dcterms:W3CDTF">2014-07-16T10:07:10Z</dcterms:created>
  <dcterms:modified xsi:type="dcterms:W3CDTF">2015-01-23T15:02:50Z</dcterms:modified>
</cp:coreProperties>
</file>